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10288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D4FF2-D69D-4851-8AAD-D0DF4235C0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88743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05960" y="4098240"/>
            <a:ext cx="88743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D28AC-9EB8-4CA3-BE22-C008EC924B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348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05960" y="409824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3480" y="409824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5FD3A-2994-4D6B-BCF3-820C9009B5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06560" y="182520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707160" y="182520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05960" y="409824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06560" y="409824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707160" y="4098240"/>
            <a:ext cx="285732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9B24E-48A5-481F-9DE0-49E6DF84D8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05960" y="1825200"/>
            <a:ext cx="887436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50"/>
              </a:spcBef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A4F5B-4901-44D8-BDA1-300ECCAB3D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88743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BB533-ED80-49AD-84F4-1CA9036C1E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4330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3480" y="1825200"/>
            <a:ext cx="4330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17DDE-D18F-4C22-9459-CC962BE814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1B0B1-2FBF-48E1-A3BC-FAF4922AE8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05960" y="365040"/>
            <a:ext cx="887436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50"/>
              </a:spcBef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D1B77-F0F1-4B13-ABAC-76DEEC37BF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3480" y="1825200"/>
            <a:ext cx="4330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05960" y="409824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71795-5EC0-4E98-8D65-EC6460160D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4330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348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3480" y="409824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A5A31-120A-4F15-8F94-0A418B104F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0596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3480" y="1825200"/>
            <a:ext cx="4330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05960" y="4098240"/>
            <a:ext cx="88743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34BCF-EF91-488A-9A9F-9CA1D56E1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05960" y="365040"/>
            <a:ext cx="887436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Yu Gothic Light"/>
              </a:rPr>
              <a:t>Click to edit the title text format</a:t>
            </a:r>
            <a:endParaRPr b="0" lang="en-US" sz="3700" spc="-1" strike="noStrike">
              <a:solidFill>
                <a:srgbClr val="000000"/>
              </a:solidFill>
              <a:latin typeface="Yu Gothic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05960" y="1825200"/>
            <a:ext cx="88743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92240" indent="-19224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1" marL="577800" indent="-1918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2" marL="963720" indent="-19224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3" marL="1349280" indent="-1918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4" marL="1735200" indent="-19224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5" marL="1735200" indent="-19224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  <a:p>
            <a:pPr lvl="6" marL="1735200" indent="-19224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Yu Gothic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Yu Gothic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06320" y="6356520"/>
            <a:ext cx="23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08480" y="6356520"/>
            <a:ext cx="3471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65880" y="6356520"/>
            <a:ext cx="23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84F45D-667A-43EB-8506-F5A808926B9A}" type="slidenum">
              <a:rPr b="0" lang="en-US" sz="10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39840" y="2170080"/>
          <a:ext cx="8129520" cy="2293920"/>
        </p:xfrm>
        <a:graphic>
          <a:graphicData uri="http://schemas.openxmlformats.org/drawingml/2006/table">
            <a:tbl>
              <a:tblPr/>
              <a:tblGrid>
                <a:gridCol w="95400"/>
                <a:gridCol w="1027080"/>
                <a:gridCol w="91800"/>
                <a:gridCol w="42840"/>
                <a:gridCol w="35280"/>
                <a:gridCol w="601560"/>
                <a:gridCol w="507960"/>
                <a:gridCol w="108000"/>
                <a:gridCol w="108000"/>
                <a:gridCol w="1095120"/>
                <a:gridCol w="119160"/>
                <a:gridCol w="33480"/>
                <a:gridCol w="90360"/>
                <a:gridCol w="434880"/>
                <a:gridCol w="462240"/>
                <a:gridCol w="48240"/>
                <a:gridCol w="81000"/>
                <a:gridCol w="979560"/>
                <a:gridCol w="95040"/>
                <a:gridCol w="300240"/>
                <a:gridCol w="99720"/>
                <a:gridCol w="1672560"/>
              </a:tblGrid>
              <a:tr h="378000"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53680"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   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No. (%) of embryo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No. (%) of pup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 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No. of live male chimera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55120"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Transferr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Pups bor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Analyz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Chimera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ST-analyz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GFP-positiv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25240"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12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6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(5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6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5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(8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1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2240">
                <a:tc>
                  <a:txBody>
                    <a:bodyPr lIns="6120" rIns="6120" tIns="61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200" spc="-1" strike="noStrike">
                          <a:solidFill>
                            <a:srgbClr val="000000"/>
                          </a:solidFill>
                          <a:latin typeface="メイリオ"/>
                          <a:ea typeface="メイリオ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2"/>
          <p:cNvSpPr/>
          <p:nvPr/>
        </p:nvSpPr>
        <p:spPr>
          <a:xfrm>
            <a:off x="1242000" y="4702320"/>
            <a:ext cx="205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メイリオ"/>
              </a:rPr>
              <a:t>ST, seminiferous tubu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4"/>
          <p:cNvSpPr/>
          <p:nvPr/>
        </p:nvSpPr>
        <p:spPr>
          <a:xfrm>
            <a:off x="1109520" y="1503360"/>
            <a:ext cx="8790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メイリオ"/>
              </a:rPr>
              <a:t>Supplementary Table 1. Generation of chimeric rats by blastocyst injection of rat ES (HSA21-EGFP) cells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1822320" y="1922400"/>
          <a:ext cx="7097760" cy="2606760"/>
        </p:xfrm>
        <a:graphic>
          <a:graphicData uri="http://schemas.openxmlformats.org/drawingml/2006/table">
            <a:tbl>
              <a:tblPr/>
              <a:tblGrid>
                <a:gridCol w="1333800"/>
                <a:gridCol w="122040"/>
                <a:gridCol w="596880"/>
                <a:gridCol w="96840"/>
                <a:gridCol w="744480"/>
                <a:gridCol w="87480"/>
                <a:gridCol w="1158840"/>
                <a:gridCol w="115920"/>
                <a:gridCol w="522360"/>
                <a:gridCol w="841320"/>
                <a:gridCol w="115920"/>
                <a:gridCol w="42840"/>
                <a:gridCol w="546120"/>
                <a:gridCol w="666720"/>
                <a:gridCol w="106200"/>
              </a:tblGrid>
              <a:tr h="29052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メイリオ"/>
                          <a:ea typeface="Yu Gothic"/>
                        </a:rPr>
                        <a:t>　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 gridSpan="6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          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No.(%) of oocyt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     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No. (%) of pup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64116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Inject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Surviv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Transferre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Bor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With GFP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600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8564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6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6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(8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6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1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(21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(3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86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ja-JP" sz="1600" spc="-1" strike="noStrike">
                          <a:solidFill>
                            <a:srgbClr val="000000"/>
                          </a:solidFill>
                          <a:latin typeface="Arial"/>
                          <a:ea typeface="メイリオ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テキスト ボックス 2"/>
          <p:cNvSpPr/>
          <p:nvPr/>
        </p:nvSpPr>
        <p:spPr>
          <a:xfrm>
            <a:off x="1772640" y="1432080"/>
            <a:ext cx="712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メイリオ"/>
              </a:rPr>
              <a:t>Supplementary Table 2. Generation of germline competent rats via ROS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112680" y="539640"/>
            <a:ext cx="9933120" cy="588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1480"/>
                <a:tab algn="l" pos="1542960"/>
                <a:tab algn="l" pos="2314440"/>
                <a:tab algn="l" pos="3086280"/>
                <a:tab algn="l" pos="3857760"/>
                <a:tab algn="l" pos="4629240"/>
                <a:tab algn="l" pos="5400720"/>
                <a:tab algn="l" pos="6172200"/>
                <a:tab algn="l" pos="6943680"/>
                <a:tab algn="l" pos="7715160"/>
                <a:tab algn="l" pos="8486640"/>
                <a:tab algn="l" pos="9258480"/>
                <a:tab algn="l" pos="10029960"/>
                <a:tab algn="l" pos="108014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5. </a:t>
            </a:r>
            <a:r>
              <a:rPr b="1" lang="en-US" sz="1600" spc="-1" strike="noStrike">
                <a:solidFill>
                  <a:srgbClr val="212121"/>
                </a:solidFill>
                <a:latin typeface="Arial"/>
                <a:ea typeface="MS Mincho"/>
              </a:rPr>
              <a:t>The global gene dosage effects of the HSA21 in the P1 TcHSA21rat forebrain</a:t>
            </a:r>
            <a:endParaRPr b="0" lang="en-US" sz="1600" spc="-1" strike="noStrike">
              <a:solidFill>
                <a:srgbClr val="000000"/>
              </a:solidFill>
              <a:latin typeface="Yu Gothic Light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112680" y="1231920"/>
          <a:ext cx="10061640" cy="1593720"/>
        </p:xfrm>
        <a:graphic>
          <a:graphicData uri="http://schemas.openxmlformats.org/drawingml/2006/table">
            <a:tbl>
              <a:tblPr/>
              <a:tblGrid>
                <a:gridCol w="137016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944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</a:tblGrid>
              <a:tr h="39852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9852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 genes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5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9816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n Eu with FPKM≥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4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9852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DengXian"/>
                        </a:rPr>
                        <a:t>%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DengXi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8" name=""/>
          <p:cNvGraphicFramePr/>
          <p:nvPr/>
        </p:nvGraphicFramePr>
        <p:xfrm>
          <a:off x="112680" y="3032280"/>
          <a:ext cx="10061640" cy="1852560"/>
        </p:xfrm>
        <a:graphic>
          <a:graphicData uri="http://schemas.openxmlformats.org/drawingml/2006/table">
            <a:tbl>
              <a:tblPr/>
              <a:tblGrid>
                <a:gridCol w="137016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944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  <a:gridCol w="377640"/>
                <a:gridCol w="378000"/>
              </a:tblGrid>
              <a:tr h="30852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ong genes with FPKM≥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r 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74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with Tc/Eu&lt;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156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30888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with Tc/Eu&gt;1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156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45936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with Tc/Eu between 0.8 and 1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5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  <a:tr h="156240"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bf5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3" descr="Table&#10;&#10;Description automatically generated"/>
          <p:cNvPicPr/>
          <p:nvPr/>
        </p:nvPicPr>
        <p:blipFill>
          <a:blip r:embed="rId1"/>
          <a:stretch/>
        </p:blipFill>
        <p:spPr>
          <a:xfrm>
            <a:off x="2975040" y="965160"/>
            <a:ext cx="4697280" cy="5678640"/>
          </a:xfrm>
          <a:prstGeom prst="rect">
            <a:avLst/>
          </a:prstGeom>
          <a:ln w="0">
            <a:noFill/>
          </a:ln>
        </p:spPr>
      </p:pic>
      <p:sp>
        <p:nvSpPr>
          <p:cNvPr id="50" name="TextBox 5"/>
          <p:cNvSpPr/>
          <p:nvPr/>
        </p:nvSpPr>
        <p:spPr>
          <a:xfrm>
            <a:off x="1343160" y="320760"/>
            <a:ext cx="7845120" cy="61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7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7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Calibri"/>
              </a:rPr>
              <a:t>Definitions of landmarks used in the study (the landmark numbers correspond to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xtended Data Fig. 4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Calibri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テキスト ボックス 2"/>
          <p:cNvSpPr/>
          <p:nvPr/>
        </p:nvSpPr>
        <p:spPr>
          <a:xfrm>
            <a:off x="135360" y="1236600"/>
            <a:ext cx="6979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メイリオ"/>
              </a:rPr>
              <a:t>Supplementary Table 8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メイリオ"/>
              </a:rPr>
              <a:t>Husbandry from TcHSA21rat female transmi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222120" y="2106720"/>
          <a:ext cx="9842760" cy="2046240"/>
        </p:xfrm>
        <a:graphic>
          <a:graphicData uri="http://schemas.openxmlformats.org/drawingml/2006/table">
            <a:tbl>
              <a:tblPr/>
              <a:tblGrid>
                <a:gridCol w="1349640"/>
                <a:gridCol w="1238040"/>
                <a:gridCol w="844560"/>
                <a:gridCol w="966960"/>
                <a:gridCol w="1131840"/>
                <a:gridCol w="1096920"/>
                <a:gridCol w="1071720"/>
                <a:gridCol w="2143080"/>
              </a:tblGrid>
              <a:tr h="1065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kgroun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tter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tter siz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HSA2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HSA2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tio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HSA21 male ratio (of total TcHSA21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1400">
                <a:tc rowSpan="2"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ista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gt; P3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26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197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.7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4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9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20.5-E22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4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8.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771480"/>
                          <a:tab algn="l" pos="1542960"/>
                          <a:tab algn="l" pos="2314440"/>
                          <a:tab algn="l" pos="3086280"/>
                          <a:tab algn="l" pos="3857760"/>
                          <a:tab algn="l" pos="4629240"/>
                          <a:tab algn="l" pos="5400720"/>
                          <a:tab algn="l" pos="6172200"/>
                          <a:tab algn="l" pos="6943680"/>
                          <a:tab algn="l" pos="7715160"/>
                          <a:tab algn="l" pos="8486640"/>
                          <a:tab algn="l" pos="9258480"/>
                          <a:tab algn="l" pos="10029960"/>
                          <a:tab algn="l" pos="1080144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2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Yu Gothic"/>
                        </a:rPr>
                        <a:t>45.5%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know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21T05:14:55Z</dcterms:created>
  <dc:creator>香月 康宏</dc:creator>
  <dc:description/>
  <dc:language>en-US</dc:language>
  <cp:lastModifiedBy>Feng Gao</cp:lastModifiedBy>
  <cp:lastPrinted>2006-10-14T08:33:44Z</cp:lastPrinted>
  <dcterms:modified xsi:type="dcterms:W3CDTF">2021-05-30T07:22:47Z</dcterms:modified>
  <cp:revision>450</cp:revision>
  <dc:subject/>
  <dc:title>PowerPoint プレゼンテーション</dc:title>
</cp:coreProperties>
</file>